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5CEF1-264E-45ED-B790-0BCBA4AECC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5FE618-D125-4536-8BDC-2598666298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4AEEB-19D7-47CC-917E-4F147917D9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23E3F-A422-4139-A08E-F935F3D626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F16D8-A08A-40BF-885D-8407BA464E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8C24F-61F8-464A-8212-CE7D82C5D5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0C50C-7782-4137-910B-A0A0B9F2CC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85C9E-1D05-4875-9161-04E904A136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93D0C-60FE-49ED-AC66-DB6E820A83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D93EA-2EB3-43AB-919F-182E7AE4FE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2797F-95AB-4735-9370-1A12BD30F7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E390FC-6EF7-4837-BF20-817DF414BC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768408-663A-4AF7-8088-0B94C44F8369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4"/>
          <p:cNvSpPr/>
          <p:nvPr/>
        </p:nvSpPr>
        <p:spPr>
          <a:xfrm>
            <a:off x="1272960" y="795240"/>
            <a:ext cx="4676760" cy="176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2891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ATTGTCCGCTCTTGGACA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148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TCGTAATCACTTAGCAC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128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TTGATTAGATCTAAATTTCC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108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AGGTGCCTCTCACT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88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AACTGCATGCGGTG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68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AATTTGAACGTGGAATT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48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AAACTAGAGTTCAACAGC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46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TTTCACCGAAATCTACTTT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28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ATTTTTCGACTAATAATT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-85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AGATTCGTCAATGCGTC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+18_A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</a:rPr>
              <a:t>Nco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TG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CCAT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ACTATAAGGTTGTGCACAAGTC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1"/>
          <p:cNvSpPr/>
          <p:nvPr/>
        </p:nvSpPr>
        <p:spPr>
          <a:xfrm>
            <a:off x="1276200" y="2746440"/>
            <a:ext cx="3914640" cy="283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1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TGTTGAACTCTAGTTT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1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TTTGGGTCCTCGGG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2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AGTAGATTTCGGTGAAATGC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2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AACCGGTGTGACGC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3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TGACCCGAGGACCCA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3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GTCTGTGTGCGCG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4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AGGCGTCACACCGG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4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TGTGTCCGCACACG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5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GCGCGCGCACACA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5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ACGCACACACAGC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6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CGGCGTGTGCGGA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6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GCCTTGCGTACAAC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7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CCGGCTGTGTGTG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7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AATGGGCAACTTTGTCTCTT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8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CGCGTTGTACGCA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8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AATTACACGGTAACCGTACG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9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GACAAAGTTGCCCATT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-B_ex09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ATTTTTCGACTAATAATTATT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29"/>
          <p:cNvSpPr/>
          <p:nvPr/>
        </p:nvSpPr>
        <p:spPr>
          <a:xfrm>
            <a:off x="1273320" y="6807240"/>
            <a:ext cx="4523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-B1_ATG_EcoR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G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GAATT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TGAGACGCCGCTGG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_CTA_Not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AAGAAT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GCGGCCG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AGCACCACCGGGT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5"/>
          <p:cNvSpPr/>
          <p:nvPr/>
        </p:nvSpPr>
        <p:spPr>
          <a:xfrm>
            <a:off x="820440" y="5541840"/>
            <a:ext cx="354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EcR-A promoter constructs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20"/>
          <p:cNvSpPr/>
          <p:nvPr/>
        </p:nvSpPr>
        <p:spPr>
          <a:xfrm>
            <a:off x="1294560" y="5756400"/>
            <a:ext cx="444816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mEcR-A_-5121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CATTCATCTGCACACAAT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mEcR-A_-3932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m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    CC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CC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TGCGGAGTTCTAAAAT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mEcR-A_+309_A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co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    CATG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CCATG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TAGCAATATTCACGTTTT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ntronA2_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am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H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G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GGATC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CGGTTGTCTTACTCGTGT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ntronA2_AS_</a:t>
            </a:r>
            <a:r>
              <a:rPr b="0" i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al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CG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GTCGA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CACAATATGCCACCG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2"/>
          <p:cNvSpPr/>
          <p:nvPr/>
        </p:nvSpPr>
        <p:spPr>
          <a:xfrm>
            <a:off x="321120" y="-4680"/>
            <a:ext cx="233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ABLE S4. List of Prim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3"/>
          <p:cNvSpPr/>
          <p:nvPr/>
        </p:nvSpPr>
        <p:spPr>
          <a:xfrm>
            <a:off x="1751040" y="396720"/>
            <a:ext cx="577800" cy="1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a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4"/>
          <p:cNvSpPr/>
          <p:nvPr/>
        </p:nvSpPr>
        <p:spPr>
          <a:xfrm>
            <a:off x="3040200" y="396720"/>
            <a:ext cx="1844640" cy="1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(5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→ 3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5"/>
          <p:cNvSpPr/>
          <p:nvPr/>
        </p:nvSpPr>
        <p:spPr>
          <a:xfrm>
            <a:off x="571680" y="37944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6"/>
          <p:cNvSpPr/>
          <p:nvPr/>
        </p:nvSpPr>
        <p:spPr>
          <a:xfrm>
            <a:off x="571680" y="57960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7"/>
          <p:cNvSpPr/>
          <p:nvPr/>
        </p:nvSpPr>
        <p:spPr>
          <a:xfrm>
            <a:off x="404640" y="9056520"/>
            <a:ext cx="6120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6"/>
          <p:cNvSpPr/>
          <p:nvPr/>
        </p:nvSpPr>
        <p:spPr>
          <a:xfrm>
            <a:off x="614880" y="9201240"/>
            <a:ext cx="572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derlined letters indicate restriction sites used for subcloning. Mutagenized nucleotides are bol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7"/>
          <p:cNvSpPr/>
          <p:nvPr/>
        </p:nvSpPr>
        <p:spPr>
          <a:xfrm>
            <a:off x="820080" y="596880"/>
            <a:ext cx="39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HR3-B promoter deletion constructs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9"/>
          <p:cNvSpPr/>
          <p:nvPr/>
        </p:nvSpPr>
        <p:spPr>
          <a:xfrm>
            <a:off x="820080" y="2506680"/>
            <a:ext cx="39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HR3-B promoter excision constructs of luciferase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2"/>
          <p:cNvSpPr/>
          <p:nvPr/>
        </p:nvSpPr>
        <p:spPr>
          <a:xfrm>
            <a:off x="1270080" y="7473960"/>
            <a:ext cx="4600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USP_ATG_EcoR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G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GAATT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TGTCGAGCGTGGCGA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USP_ATG_NotI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AAGAAT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Courier New"/>
              </a:rPr>
              <a:t>GCGGCCG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ATGATGTTGGTGT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65"/>
          <p:cNvSpPr/>
          <p:nvPr/>
        </p:nvSpPr>
        <p:spPr>
          <a:xfrm>
            <a:off x="845280" y="6602400"/>
            <a:ext cx="28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EcR-B1 over-expression constru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65"/>
          <p:cNvSpPr/>
          <p:nvPr/>
        </p:nvSpPr>
        <p:spPr>
          <a:xfrm>
            <a:off x="816120" y="7248600"/>
            <a:ext cx="269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BmUSP over-expression constru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65"/>
          <p:cNvSpPr/>
          <p:nvPr/>
        </p:nvSpPr>
        <p:spPr>
          <a:xfrm>
            <a:off x="861840" y="7905600"/>
            <a:ext cx="40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s for EcRE swapping construct between BmE75-A and BHR3-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0"/>
          <p:cNvSpPr/>
          <p:nvPr/>
        </p:nvSpPr>
        <p:spPr>
          <a:xfrm>
            <a:off x="981000" y="8193240"/>
            <a:ext cx="4324320" cy="71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BHR3B_muE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AA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CT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CGCCT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BHR3B_muE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C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CCCGAGGACCCAAA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E75A_muB_S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CGAA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GG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GCTC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E75A_muB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CCCGAACCTTGCGGC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9T11:11:12Z</dcterms:created>
  <dc:creator>白井博之</dc:creator>
  <dc:description/>
  <dc:language>en-US</dc:language>
  <cp:lastModifiedBy> </cp:lastModifiedBy>
  <dcterms:modified xsi:type="dcterms:W3CDTF">2012-05-17T06:12:55Z</dcterms:modified>
  <cp:revision>22</cp:revision>
  <dc:subject/>
  <dc:title>スライド 1</dc:title>
</cp:coreProperties>
</file>